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58" r:id="rId4"/>
    <p:sldId id="257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F0D901F-57AE-BB0B-FE13-3EFB8FE32D7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1C969DA-5FE3-3C34-5E45-CFE7D45C356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FF29D36-052C-006B-FF46-135FDE06F6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F3F5FB-B142-4747-B414-B00898BEBDF5}" type="datetimeFigureOut">
              <a:rPr lang="zh-CN" altLang="en-US" smtClean="0"/>
              <a:t>2023/10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67251A5-4C86-5830-B26D-BB91D3C00A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750C90F-2FD0-C6C6-E279-EAC1BBD3ED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6B191-7FCE-40A2-94AD-A5DB9687B3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91995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C2F8969-0768-357C-45B6-CEE34F2878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C8169B7-12B2-F63C-FB3D-745CFE1BBB9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C4E245B-3909-6CF8-9010-E743CBC3AF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F3F5FB-B142-4747-B414-B00898BEBDF5}" type="datetimeFigureOut">
              <a:rPr lang="zh-CN" altLang="en-US" smtClean="0"/>
              <a:t>2023/10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AC8710D-2A6C-71D2-7E66-15059E35A7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0F2432D-389C-8881-D411-7BE5D6EEF3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6B191-7FCE-40A2-94AD-A5DB9687B3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90488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96891E2-C1DE-4075-4EA3-97EC145543F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AC64072-49BD-901F-95DF-93F77B33B8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8A77D61-D1FA-40CE-9184-B40A32C3D2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F3F5FB-B142-4747-B414-B00898BEBDF5}" type="datetimeFigureOut">
              <a:rPr lang="zh-CN" altLang="en-US" smtClean="0"/>
              <a:t>2023/10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9447653-EE08-432F-0766-39798B4BE7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F5A2A11-014B-606F-3DA2-9418BF58E3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6B191-7FCE-40A2-94AD-A5DB9687B3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77875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0512D67-09CE-4B49-2DF7-0BB2AED636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3CA3C20-B9E8-A0E1-141D-E09A7128690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3828B4D-9BBD-4A3C-B5D9-703A543B0C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F3F5FB-B142-4747-B414-B00898BEBDF5}" type="datetimeFigureOut">
              <a:rPr lang="zh-CN" altLang="en-US" smtClean="0"/>
              <a:t>2023/10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846F11F-81DC-EF5C-3FD7-4E3F35866C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0C196D4-E517-EF94-FB12-2BDEE32058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6B191-7FCE-40A2-94AD-A5DB9687B3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71955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8471072-C112-D521-7B97-D2B3DAD166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CCF8E3F-8A28-865D-9BA0-57B181016E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C2F0BF8-4078-4FD5-5F27-78F88EB57B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F3F5FB-B142-4747-B414-B00898BEBDF5}" type="datetimeFigureOut">
              <a:rPr lang="zh-CN" altLang="en-US" smtClean="0"/>
              <a:t>2023/10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0C964EC-B030-75F4-5961-91AD5FE838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957C9A4-EC7C-9D88-38B6-EF3D267420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6B191-7FCE-40A2-94AD-A5DB9687B3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40389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C7CA2FE-E9EC-FCDF-C0A2-32127A2356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A530A7B-B19C-DAF0-8FB0-37832D0793D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CCFBC71-AFA0-007F-A230-CC04B8AD37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B2B359B-794D-DBC6-0BA2-080C10979A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F3F5FB-B142-4747-B414-B00898BEBDF5}" type="datetimeFigureOut">
              <a:rPr lang="zh-CN" altLang="en-US" smtClean="0"/>
              <a:t>2023/10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A595946-D813-F844-49A3-4573DFEEE0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DD3EB92-261E-73A3-E931-4B7627691C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6B191-7FCE-40A2-94AD-A5DB9687B3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73790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705F85C-8B38-8722-082F-FF972756E7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20884BB-B6E8-B592-162E-18D6859632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1B3FA94-4241-CCD0-0324-12C1E4A294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005BE657-5D36-52C1-788E-87CA3815D1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4F69FFF-4090-31E0-1671-087D5D08B27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A115867E-1DF3-935F-A590-135E538E07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F3F5FB-B142-4747-B414-B00898BEBDF5}" type="datetimeFigureOut">
              <a:rPr lang="zh-CN" altLang="en-US" smtClean="0"/>
              <a:t>2023/10/1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743A136-ECDD-E84E-8BE8-59B772092A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DFD4F66A-387F-45F2-B1D4-B55D45A663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6B191-7FCE-40A2-94AD-A5DB9687B3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40833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1FEB848-072A-5293-A0CE-EA329169FF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34635FD-881F-1733-BB1F-EEE7D5F13F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F3F5FB-B142-4747-B414-B00898BEBDF5}" type="datetimeFigureOut">
              <a:rPr lang="zh-CN" altLang="en-US" smtClean="0"/>
              <a:t>2023/10/1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6D8D559-CD0F-3B6A-6EC9-0CF0685480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EEAF06D5-EF7F-6020-0C8D-22AB9ED857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6B191-7FCE-40A2-94AD-A5DB9687B3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90870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9809ECD-EE1D-047F-3036-6CE2C71F97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F3F5FB-B142-4747-B414-B00898BEBDF5}" type="datetimeFigureOut">
              <a:rPr lang="zh-CN" altLang="en-US" smtClean="0"/>
              <a:t>2023/10/1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CB93BAA-6F4E-E3E2-9249-69DA3EE273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438A261-1D99-6718-31B2-FB3DC3A774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6B191-7FCE-40A2-94AD-A5DB9687B3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71676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D08F0EF-2622-FDDF-B266-65938C7D98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E471900-859A-AB1E-EC48-14A29D9670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9DDA4DD-1B4F-D0B4-2B36-D5215EC314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1B7DC3E-0E72-EBED-42D5-CFF2A0E118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F3F5FB-B142-4747-B414-B00898BEBDF5}" type="datetimeFigureOut">
              <a:rPr lang="zh-CN" altLang="en-US" smtClean="0"/>
              <a:t>2023/10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9976920-700A-8212-728E-08B11AA7E3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362658C-E399-BBD2-EA18-04E826DA81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6B191-7FCE-40A2-94AD-A5DB9687B3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92241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A44F80D-EFBB-9790-61AC-2FF47D97F7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7E82C5A-50B9-ECB9-1C58-905B80C4C0B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26C2CF4-FD06-8855-FE42-E84E67196B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5F68C9C-9596-DCB5-252A-FBB13DDA71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F3F5FB-B142-4747-B414-B00898BEBDF5}" type="datetimeFigureOut">
              <a:rPr lang="zh-CN" altLang="en-US" smtClean="0"/>
              <a:t>2023/10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F9A68A7-DA30-C0D2-B2ED-D03E2968A6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20A72CE-9DD4-59A2-2A83-B01161CC42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6B191-7FCE-40A2-94AD-A5DB9687B3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22955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95202B3-D401-BD7B-FA0C-7ACCD28F81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8795D26-8661-B0AD-30F8-1CF11C5D47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9F1943F-BF02-ECA7-8300-DD97B008350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F3F5FB-B142-4747-B414-B00898BEBDF5}" type="datetimeFigureOut">
              <a:rPr lang="zh-CN" altLang="en-US" smtClean="0"/>
              <a:t>2023/10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9A17611-88B9-50C6-C047-9A8688E27E7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8623D1E-AA5C-5B7A-1777-557836CD85E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46B191-7FCE-40A2-94AD-A5DB9687B3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412340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7" Type="http://schemas.openxmlformats.org/officeDocument/2006/relationships/image" Target="../media/image12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jpg"/><Relationship Id="rId5" Type="http://schemas.openxmlformats.org/officeDocument/2006/relationships/image" Target="../media/image10.jpg"/><Relationship Id="rId4" Type="http://schemas.openxmlformats.org/officeDocument/2006/relationships/image" Target="../media/image9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jpg"/><Relationship Id="rId4" Type="http://schemas.openxmlformats.org/officeDocument/2006/relationships/image" Target="../media/image15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337037EC-E8E4-A72E-0110-B7F06172692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1915" y="5027979"/>
            <a:ext cx="3738372" cy="102108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69762310-0644-88A6-E60E-151DCDFEDBC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2029" y="2259945"/>
            <a:ext cx="3858258" cy="893533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47876916-8915-7683-FCDD-BC9683898F9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8863" y="3302587"/>
            <a:ext cx="3771900" cy="1594104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DAE6996E-67CB-D81F-7546-EEE0F78ED44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8388" y="788536"/>
            <a:ext cx="3771899" cy="1306468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BB2807F0-950F-8123-B1CB-0BB2617FA8BC}"/>
              </a:ext>
            </a:extLst>
          </p:cNvPr>
          <p:cNvSpPr txBox="1"/>
          <p:nvPr/>
        </p:nvSpPr>
        <p:spPr>
          <a:xfrm>
            <a:off x="5649067" y="1786341"/>
            <a:ext cx="7873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P-Nrf2</a:t>
            </a:r>
            <a:endParaRPr lang="zh-CN" altLang="en-US" sz="1600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6EC86526-BC72-270B-55EC-C103F3469571}"/>
              </a:ext>
            </a:extLst>
          </p:cNvPr>
          <p:cNvSpPr txBox="1"/>
          <p:nvPr/>
        </p:nvSpPr>
        <p:spPr>
          <a:xfrm>
            <a:off x="5649067" y="2914776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Nrf2</a:t>
            </a:r>
            <a:endParaRPr lang="zh-CN" altLang="en-US" sz="1600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79545ABF-28A9-B119-4532-53BC18B93FDE}"/>
              </a:ext>
            </a:extLst>
          </p:cNvPr>
          <p:cNvSpPr txBox="1"/>
          <p:nvPr/>
        </p:nvSpPr>
        <p:spPr>
          <a:xfrm>
            <a:off x="5699436" y="5794057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HDAC1</a:t>
            </a:r>
            <a:endParaRPr lang="zh-CN" altLang="en-US" sz="1600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B5FEE905-AC8A-BE5F-F365-DF6DE8B814A5}"/>
              </a:ext>
            </a:extLst>
          </p:cNvPr>
          <p:cNvSpPr txBox="1"/>
          <p:nvPr/>
        </p:nvSpPr>
        <p:spPr>
          <a:xfrm>
            <a:off x="5660287" y="4589573"/>
            <a:ext cx="8226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Nrf2-N</a:t>
            </a:r>
            <a:endParaRPr lang="zh-CN" altLang="en-US" sz="1600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A3A2FBE3-4067-C5E2-650B-6FBA1B3C72EE}"/>
              </a:ext>
            </a:extLst>
          </p:cNvPr>
          <p:cNvSpPr txBox="1"/>
          <p:nvPr/>
        </p:nvSpPr>
        <p:spPr>
          <a:xfrm>
            <a:off x="584664" y="619259"/>
            <a:ext cx="105509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/>
              <a:t>Figure.1B</a:t>
            </a:r>
            <a:endParaRPr lang="zh-CN" alt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3732074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6AB65F96-4180-2F31-33E9-08EBC52D1FC5}"/>
              </a:ext>
            </a:extLst>
          </p:cNvPr>
          <p:cNvSpPr txBox="1"/>
          <p:nvPr/>
        </p:nvSpPr>
        <p:spPr>
          <a:xfrm>
            <a:off x="1376135" y="1316223"/>
            <a:ext cx="1079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/>
              <a:t>Figure.2D</a:t>
            </a:r>
            <a:endParaRPr lang="zh-CN" altLang="en-US" sz="1600" b="1" dirty="0"/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5C6F7638-D2C9-329A-53EB-3C748570C37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00833" y="1139308"/>
            <a:ext cx="1845713" cy="2112777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403AD444-883E-A6B4-9C47-640917BDF77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3600" y="1654777"/>
            <a:ext cx="3439329" cy="13201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22373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文本框 11">
            <a:extLst>
              <a:ext uri="{FF2B5EF4-FFF2-40B4-BE49-F238E27FC236}">
                <a16:creationId xmlns:a16="http://schemas.microsoft.com/office/drawing/2014/main" id="{7A5F1FE2-0314-01AC-FE17-88A69CB633DC}"/>
              </a:ext>
            </a:extLst>
          </p:cNvPr>
          <p:cNvSpPr txBox="1"/>
          <p:nvPr/>
        </p:nvSpPr>
        <p:spPr>
          <a:xfrm>
            <a:off x="4954224" y="1509040"/>
            <a:ext cx="8226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Nrf2-N</a:t>
            </a:r>
            <a:endParaRPr lang="zh-CN" altLang="en-US" sz="1600" dirty="0"/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D7A33263-99B6-C94D-E901-07F50671A29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5412" y="4082767"/>
            <a:ext cx="3095244" cy="912876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04DD90AB-74E7-B904-010A-40BD0910A6A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3037" y="1920803"/>
            <a:ext cx="3023616" cy="1040892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03A4B833-88F6-0191-251E-11105FD9550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0296" y="673055"/>
            <a:ext cx="3019044" cy="1101852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142E1C56-7187-3A03-1837-ACE652F2B1B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8621" y="3088653"/>
            <a:ext cx="2639568" cy="867156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3F650B0D-9B9F-9DCB-9284-83757F3E07A3}"/>
              </a:ext>
            </a:extLst>
          </p:cNvPr>
          <p:cNvSpPr txBox="1"/>
          <p:nvPr/>
        </p:nvSpPr>
        <p:spPr>
          <a:xfrm>
            <a:off x="4940656" y="2659774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HDAC1</a:t>
            </a:r>
            <a:endParaRPr lang="zh-CN" altLang="en-US" sz="1600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1C170C47-83B0-3E7E-04B3-841354554C2D}"/>
              </a:ext>
            </a:extLst>
          </p:cNvPr>
          <p:cNvSpPr txBox="1"/>
          <p:nvPr/>
        </p:nvSpPr>
        <p:spPr>
          <a:xfrm>
            <a:off x="4954224" y="3641231"/>
            <a:ext cx="8627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TRAP-1</a:t>
            </a:r>
            <a:endParaRPr lang="zh-CN" altLang="en-US" sz="1600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246F95E9-ABFA-6CB7-28F6-B5FADBC24DCC}"/>
              </a:ext>
            </a:extLst>
          </p:cNvPr>
          <p:cNvSpPr txBox="1"/>
          <p:nvPr/>
        </p:nvSpPr>
        <p:spPr>
          <a:xfrm>
            <a:off x="4998189" y="4698839"/>
            <a:ext cx="10967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Beta-actin</a:t>
            </a:r>
            <a:endParaRPr lang="zh-CN" altLang="en-US" sz="1600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C7D74FFD-4860-512A-6D66-20A447FF32AC}"/>
              </a:ext>
            </a:extLst>
          </p:cNvPr>
          <p:cNvSpPr txBox="1"/>
          <p:nvPr/>
        </p:nvSpPr>
        <p:spPr>
          <a:xfrm>
            <a:off x="851811" y="597596"/>
            <a:ext cx="105509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/>
              <a:t>Figure.3B</a:t>
            </a:r>
            <a:endParaRPr lang="zh-CN" altLang="en-US" sz="1600" b="1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7E6DA969-55D7-42C9-96F1-9384C93DAD6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26531" y="2988803"/>
            <a:ext cx="3173196" cy="1062257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45502EF6-6DB0-93CD-D0E7-0F2EE729A64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12256" y="1377033"/>
            <a:ext cx="3194584" cy="1442783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5DFD2484-1429-68C7-02B9-AAC5416C4FA0}"/>
              </a:ext>
            </a:extLst>
          </p:cNvPr>
          <p:cNvSpPr txBox="1"/>
          <p:nvPr/>
        </p:nvSpPr>
        <p:spPr>
          <a:xfrm>
            <a:off x="10611428" y="2565756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Nrf2</a:t>
            </a:r>
            <a:endParaRPr lang="zh-CN" altLang="en-US" sz="1600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C3609039-35B8-FE27-6FD8-A5907A6FBB23}"/>
              </a:ext>
            </a:extLst>
          </p:cNvPr>
          <p:cNvSpPr txBox="1"/>
          <p:nvPr/>
        </p:nvSpPr>
        <p:spPr>
          <a:xfrm>
            <a:off x="10611428" y="3796381"/>
            <a:ext cx="10967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Beta-actin</a:t>
            </a:r>
            <a:endParaRPr lang="zh-CN" altLang="en-US" sz="1600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9DD5C275-68E1-B1DA-BA1B-E2685BEE749C}"/>
              </a:ext>
            </a:extLst>
          </p:cNvPr>
          <p:cNvSpPr txBox="1"/>
          <p:nvPr/>
        </p:nvSpPr>
        <p:spPr>
          <a:xfrm>
            <a:off x="6449846" y="1336071"/>
            <a:ext cx="1079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/>
              <a:t>Figure.3D</a:t>
            </a:r>
            <a:endParaRPr lang="zh-CN" alt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4955616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图片 19">
            <a:extLst>
              <a:ext uri="{FF2B5EF4-FFF2-40B4-BE49-F238E27FC236}">
                <a16:creationId xmlns:a16="http://schemas.microsoft.com/office/drawing/2014/main" id="{D8F6EC01-E4E0-6A2F-49EB-7BCBC0185F6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5769" y="3759411"/>
            <a:ext cx="3821070" cy="1165013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5DDE1F7E-0ADB-9882-E179-A4EF96CE12E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5769" y="5007226"/>
            <a:ext cx="3821070" cy="1557135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564FA82F-5A5C-6939-B5B9-4564B3F9F78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9672" y="2346388"/>
            <a:ext cx="3659255" cy="1273112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084D6E38-39E3-2565-BD5A-39B5DF81FE9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4592" y="855020"/>
            <a:ext cx="3572247" cy="1351456"/>
          </a:xfrm>
          <a:prstGeom prst="rect">
            <a:avLst/>
          </a:prstGeom>
        </p:spPr>
      </p:pic>
      <p:sp>
        <p:nvSpPr>
          <p:cNvPr id="24" name="文本框 23">
            <a:extLst>
              <a:ext uri="{FF2B5EF4-FFF2-40B4-BE49-F238E27FC236}">
                <a16:creationId xmlns:a16="http://schemas.microsoft.com/office/drawing/2014/main" id="{E39195DF-840D-2ED7-F76B-D12A1C278A15}"/>
              </a:ext>
            </a:extLst>
          </p:cNvPr>
          <p:cNvSpPr txBox="1"/>
          <p:nvPr/>
        </p:nvSpPr>
        <p:spPr>
          <a:xfrm>
            <a:off x="4872314" y="1867922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FAP</a:t>
            </a:r>
            <a:endParaRPr lang="zh-CN" altLang="en-US" sz="1600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C6CDCCB9-4BB8-B59E-8091-049B56B0AD7C}"/>
              </a:ext>
            </a:extLst>
          </p:cNvPr>
          <p:cNvSpPr txBox="1"/>
          <p:nvPr/>
        </p:nvSpPr>
        <p:spPr>
          <a:xfrm>
            <a:off x="4878085" y="4651525"/>
            <a:ext cx="10406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Alfa-SMA</a:t>
            </a:r>
            <a:endParaRPr lang="zh-CN" altLang="en-US" sz="1600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8801B7C7-3C58-5425-A276-A64B6A427241}"/>
              </a:ext>
            </a:extLst>
          </p:cNvPr>
          <p:cNvSpPr txBox="1"/>
          <p:nvPr/>
        </p:nvSpPr>
        <p:spPr>
          <a:xfrm>
            <a:off x="4878085" y="6256884"/>
            <a:ext cx="10502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Beta actin</a:t>
            </a:r>
            <a:endParaRPr lang="zh-CN" altLang="en-US" sz="1600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2BB14B22-D35D-387D-D505-2789FC6BD5F2}"/>
              </a:ext>
            </a:extLst>
          </p:cNvPr>
          <p:cNvSpPr txBox="1"/>
          <p:nvPr/>
        </p:nvSpPr>
        <p:spPr>
          <a:xfrm>
            <a:off x="847764" y="506128"/>
            <a:ext cx="10374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/>
              <a:t>Figure.5E</a:t>
            </a:r>
            <a:endParaRPr lang="zh-CN" altLang="en-US" sz="1600" b="1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12B20408-D383-254A-DF87-217D5E7F1714}"/>
              </a:ext>
            </a:extLst>
          </p:cNvPr>
          <p:cNvSpPr txBox="1"/>
          <p:nvPr/>
        </p:nvSpPr>
        <p:spPr>
          <a:xfrm>
            <a:off x="4816839" y="3250168"/>
            <a:ext cx="1238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/>
              <a:t>CollagenI</a:t>
            </a:r>
            <a:endParaRPr lang="zh-CN" altLang="en-US" sz="1800" dirty="0"/>
          </a:p>
        </p:txBody>
      </p:sp>
    </p:spTree>
    <p:extLst>
      <p:ext uri="{BB962C8B-B14F-4D97-AF65-F5344CB8AC3E}">
        <p14:creationId xmlns:p14="http://schemas.microsoft.com/office/powerpoint/2010/main" val="10689968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30</Words>
  <Application>Microsoft Office PowerPoint</Application>
  <PresentationFormat>宽屏</PresentationFormat>
  <Paragraphs>19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John</dc:creator>
  <cp:lastModifiedBy>yc Wang</cp:lastModifiedBy>
  <cp:revision>7</cp:revision>
  <dcterms:created xsi:type="dcterms:W3CDTF">2023-04-29T09:09:45Z</dcterms:created>
  <dcterms:modified xsi:type="dcterms:W3CDTF">2023-10-18T13:12:24Z</dcterms:modified>
</cp:coreProperties>
</file>